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01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94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A788D-A7D6-4038-95AF-8F5E13241F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411069-665C-CD4C-B12C-0DAD04DCF4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97A932-AD01-DED5-B8C9-FFF2FEBAC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F150B9-E44E-2AA8-8394-47CD3D83C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AADFFE-407D-DE52-5593-A8B246FFF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8097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8BEB59-CF2C-1C4A-9AEC-425D689D0F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3722A4-A6E7-ABE2-BF02-4F69D8AD85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F45CC-0779-A5CA-E6DF-000BEF14CE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70E6CC-099E-ABA2-9C7B-C7E489626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CD7DCE-30A4-238D-49E3-8F083E7750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1421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630853-2BC5-CA36-8C63-496C78A728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FCA993-BBAC-B21E-5999-357F55321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9D81F7-E937-08C2-64EE-56EA6D4F3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08D63A-51C2-418C-C0A6-546285F10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AAE02D-C077-596A-8658-0462CE140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177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4D612-5083-DC5C-CA85-D8F7C79889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29BF5B-4000-B7F8-0238-5511DD0F1E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4A6A03-2E48-30CD-66D3-EE249B08EE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918ED3-1C03-9B2B-ADF8-C32416148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6D6F96-ABE6-28E1-3C24-0F5DE4D47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429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69683-2292-BCE3-5281-633C71202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959318-919F-76A2-F9F2-9A7D2DDCA5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7BA58-03D0-3A8A-24FD-BE964615D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9F8AA-B07E-9132-E7BC-D4E3C818E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B2872-4ECC-83AB-923E-689FD1357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3900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7BD78-2F4B-C0E0-2EA4-04EC54D1C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D0D6C-FF90-289D-E949-17EFF6F724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94EBD8-7520-ED42-C863-48C17E8F13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FB6A5C-3998-82FA-B2BA-2D8C29326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EF3651-50ED-6FED-CDA2-C79685EA3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2EA329-AE9B-62BE-F9EE-79F8579D6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624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AA73A0-5823-A8D3-DC0A-EBA1F5A4D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89F375-F420-051B-AEB5-AFCAEC5EF2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CB3E51-147D-21BB-397E-D6D5E2C4EA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F2E9A6-47B6-A23D-F43A-F8C1988205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956C088-B2D9-310D-E70F-BD92C26B66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16D205B-8895-935E-530D-C01572135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4038A9-8282-1B69-DCBE-C3012BED1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A06B58-E163-049A-9DB0-DFAB2FBF4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940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EB129C-DAA1-A051-5AE6-64FF449D54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44599A-68D5-B5A2-C007-E076CDEA3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695C31-C731-9C25-0B03-E9730F980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05F550-75E7-0836-BFA9-16E4A590D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852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A6059F-2489-1EE4-36F3-5F8F3B781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5C8456-E6D2-F299-2587-4047A5599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FEBBC6-EB34-6B57-D60E-34D096E348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02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41C29E-7E92-2370-6161-441C4D4438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62B0E2-BF58-73DC-7F23-DBCB9DCBF8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4F639E-EE0E-7FD1-97A6-EEBCBCCDAE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057059-AD52-7D87-BC76-72F05AB0E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304066-94B4-E766-A6D3-5136DECF5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971340-9D34-744B-2E66-31FF45AC2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9603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71284-A42C-0007-D253-C06963ABFD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6427FF-D0B5-D889-52CF-9CE216E21C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CD26B83-9769-C888-CB66-6A4A7019B4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4C3380-E129-8675-2440-A09F4BCE6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A60E11-52F3-474D-6AD2-7DEBD3D07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4CC142-DBC4-596E-6CBD-0D20098B6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057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BFF39F-767C-2A49-B600-7767BDDC5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0F3F4-0459-B77A-97A8-287EE7BDD0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097DB6-55E3-90C3-4383-FB71C4FAC6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7DC029-CA14-493D-AC17-5DC46CBF4AED}" type="datetimeFigureOut">
              <a:rPr lang="en-US" smtClean="0"/>
              <a:t>06-Jun-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D9953-E86A-086C-95F6-3B3A8F7EADC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77E382-EB34-A2A4-1003-BEABECC3384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E11E23-B5E5-4AC3-9409-0468C100F5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43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png"/><Relationship Id="rId7" Type="http://schemas.openxmlformats.org/officeDocument/2006/relationships/image" Target="../media/image17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openxmlformats.org/officeDocument/2006/relationships/image" Target="../media/image6.png"/><Relationship Id="rId4" Type="http://schemas.openxmlformats.org/officeDocument/2006/relationships/image" Target="../media/image15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1.png"/><Relationship Id="rId7" Type="http://schemas.openxmlformats.org/officeDocument/2006/relationships/image" Target="../media/image24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7.png"/><Relationship Id="rId4" Type="http://schemas.openxmlformats.org/officeDocument/2006/relationships/image" Target="../media/image22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13" Type="http://schemas.openxmlformats.org/officeDocument/2006/relationships/image" Target="../media/image37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12" Type="http://schemas.openxmlformats.org/officeDocument/2006/relationships/image" Target="../media/image36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11" Type="http://schemas.openxmlformats.org/officeDocument/2006/relationships/image" Target="../media/image35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2858EBF-AC4F-D123-58BD-2CC504FE6E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8442" y="2504189"/>
            <a:ext cx="2859278" cy="208125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4D64FA9-2859-65D2-CD20-D66823F5FD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8442" y="395329"/>
            <a:ext cx="2862131" cy="210230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CB25328-DEF8-680E-8B33-D9DF9ECAE2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30441" y="4556326"/>
            <a:ext cx="2862131" cy="204869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B5288E5-4E7A-A12F-8FF8-3547E9247CE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33294" y="2497637"/>
            <a:ext cx="2862131" cy="20943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D2986CE-6DBB-CB3F-79A1-6B3F65098F0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33294" y="392533"/>
            <a:ext cx="2864984" cy="210510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3C4A77A-C6A7-7C22-02B1-68F50BF15E9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48057" y="533319"/>
            <a:ext cx="701210" cy="22808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A7F86DE-BC19-C025-CF43-415249DED64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52523" y="2631872"/>
            <a:ext cx="692277" cy="20843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4DC5DE9-06BB-FFCC-1AF3-3B3ADD07CBB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09651" y="4719928"/>
            <a:ext cx="732604" cy="21515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C55A43E-9202-AA8A-E9CC-997708F15B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20047" y="537293"/>
            <a:ext cx="699960" cy="22808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9D15423-F3A3-CCD7-95CF-D8ACCD7D9BF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227730" y="2635847"/>
            <a:ext cx="692277" cy="20843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0F187D5-EBFB-367E-BA8E-16FF88EF2F79}"/>
              </a:ext>
            </a:extLst>
          </p:cNvPr>
          <p:cNvSpPr txBox="1"/>
          <p:nvPr/>
        </p:nvSpPr>
        <p:spPr>
          <a:xfrm rot="16200000">
            <a:off x="-443368" y="1185773"/>
            <a:ext cx="1630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21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713A51A-B2F3-18F2-A9C4-D53DED5486BB}"/>
              </a:ext>
            </a:extLst>
          </p:cNvPr>
          <p:cNvSpPr txBox="1"/>
          <p:nvPr/>
        </p:nvSpPr>
        <p:spPr>
          <a:xfrm rot="16200000">
            <a:off x="-443368" y="3205726"/>
            <a:ext cx="16305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50 mRNA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241C0C-491A-29A5-CDF6-3D5361E25A6B}"/>
              </a:ext>
            </a:extLst>
          </p:cNvPr>
          <p:cNvSpPr txBox="1"/>
          <p:nvPr/>
        </p:nvSpPr>
        <p:spPr>
          <a:xfrm rot="16200000">
            <a:off x="-456313" y="5225679"/>
            <a:ext cx="16514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D1 mRNA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BF330F5-00F8-9178-3322-D5FCCAD097D8}"/>
              </a:ext>
            </a:extLst>
          </p:cNvPr>
          <p:cNvSpPr txBox="1"/>
          <p:nvPr/>
        </p:nvSpPr>
        <p:spPr>
          <a:xfrm>
            <a:off x="1522986" y="149411"/>
            <a:ext cx="10021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ohor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3C7A321-6A5B-E7B1-0A76-AF696D419460}"/>
              </a:ext>
            </a:extLst>
          </p:cNvPr>
          <p:cNvSpPr txBox="1"/>
          <p:nvPr/>
        </p:nvSpPr>
        <p:spPr>
          <a:xfrm>
            <a:off x="4284601" y="153386"/>
            <a:ext cx="1362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w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hor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248DFEB-17DC-3D2A-FA2E-ADC29D9E9F72}"/>
              </a:ext>
            </a:extLst>
          </p:cNvPr>
          <p:cNvSpPr txBox="1"/>
          <p:nvPr/>
        </p:nvSpPr>
        <p:spPr>
          <a:xfrm>
            <a:off x="7147575" y="153385"/>
            <a:ext cx="1391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High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hort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4BF724F-C7DE-7034-988F-19D67260D10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96071" y="4585440"/>
            <a:ext cx="2864984" cy="201957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5592A5B6-2CB5-0439-FEFB-5E57AD03493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52470" y="4723903"/>
            <a:ext cx="732604" cy="21515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97B6F430-0E98-E2EA-CCC6-3ECDD0DC418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90025" y="392510"/>
            <a:ext cx="2855148" cy="209259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5FF9184-04D6-340C-3F02-686657356C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92909" y="551656"/>
            <a:ext cx="701210" cy="228083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022F94D-F1E4-3D68-0E73-54BA6A813B9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0025" y="2505774"/>
            <a:ext cx="2855148" cy="205055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058E962A-B396-31C8-3DF8-60E4D968464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99310" y="2631872"/>
            <a:ext cx="692277" cy="20843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B3993612-5461-014D-035E-1177B5FEC0F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90025" y="4556090"/>
            <a:ext cx="2855148" cy="2048929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73861A86-BBFB-EA76-BCC6-82631807827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451414" y="4727388"/>
            <a:ext cx="732604" cy="21515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178D3967-65F9-7F79-2610-5345D6F200D5}"/>
              </a:ext>
            </a:extLst>
          </p:cNvPr>
          <p:cNvSpPr txBox="1"/>
          <p:nvPr/>
        </p:nvSpPr>
        <p:spPr>
          <a:xfrm>
            <a:off x="798635" y="2004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CCB65CE-8D71-5D18-FF49-00DC4BA06032}"/>
              </a:ext>
            </a:extLst>
          </p:cNvPr>
          <p:cNvSpPr txBox="1"/>
          <p:nvPr/>
        </p:nvSpPr>
        <p:spPr>
          <a:xfrm>
            <a:off x="3666107" y="20042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6066805-D7D7-D3EB-3765-18FF26A2A5F6}"/>
              </a:ext>
            </a:extLst>
          </p:cNvPr>
          <p:cNvSpPr txBox="1"/>
          <p:nvPr/>
        </p:nvSpPr>
        <p:spPr>
          <a:xfrm>
            <a:off x="6530554" y="19491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0847654-8418-970D-0084-A251797DBC42}"/>
              </a:ext>
            </a:extLst>
          </p:cNvPr>
          <p:cNvSpPr txBox="1"/>
          <p:nvPr/>
        </p:nvSpPr>
        <p:spPr>
          <a:xfrm>
            <a:off x="806664" y="23186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3590D89-1BF3-66E8-C8D9-5C82BFBCD8FE}"/>
              </a:ext>
            </a:extLst>
          </p:cNvPr>
          <p:cNvSpPr txBox="1"/>
          <p:nvPr/>
        </p:nvSpPr>
        <p:spPr>
          <a:xfrm>
            <a:off x="3678143" y="231885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90BD60F-7180-8201-11BD-B937F35CA7CF}"/>
              </a:ext>
            </a:extLst>
          </p:cNvPr>
          <p:cNvSpPr txBox="1"/>
          <p:nvPr/>
        </p:nvSpPr>
        <p:spPr>
          <a:xfrm>
            <a:off x="6546598" y="231785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98E3798-07DA-7CBB-CC49-A3961FA26A31}"/>
              </a:ext>
            </a:extLst>
          </p:cNvPr>
          <p:cNvSpPr txBox="1"/>
          <p:nvPr/>
        </p:nvSpPr>
        <p:spPr>
          <a:xfrm>
            <a:off x="820514" y="4337577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E04AF19-64BA-C301-1810-5B01A70E7E9A}"/>
              </a:ext>
            </a:extLst>
          </p:cNvPr>
          <p:cNvSpPr txBox="1"/>
          <p:nvPr/>
        </p:nvSpPr>
        <p:spPr>
          <a:xfrm>
            <a:off x="3672376" y="4337577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6565430-2F81-DF99-4C90-EB89356EF197}"/>
              </a:ext>
            </a:extLst>
          </p:cNvPr>
          <p:cNvSpPr txBox="1"/>
          <p:nvPr/>
        </p:nvSpPr>
        <p:spPr>
          <a:xfrm>
            <a:off x="6564261" y="4340427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F43DE3A-F5C3-19EB-0930-47823B71BA5F}"/>
              </a:ext>
            </a:extLst>
          </p:cNvPr>
          <p:cNvSpPr txBox="1"/>
          <p:nvPr/>
        </p:nvSpPr>
        <p:spPr>
          <a:xfrm>
            <a:off x="815612" y="1753215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97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F0F01A0-7FB1-82AB-4CA3-109B124604EF}"/>
              </a:ext>
            </a:extLst>
          </p:cNvPr>
          <p:cNvSpPr txBox="1"/>
          <p:nvPr/>
        </p:nvSpPr>
        <p:spPr>
          <a:xfrm>
            <a:off x="3676353" y="1752589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76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4F83DC0-6639-5C8F-EB4D-2646BCBA8945}"/>
              </a:ext>
            </a:extLst>
          </p:cNvPr>
          <p:cNvSpPr txBox="1"/>
          <p:nvPr/>
        </p:nvSpPr>
        <p:spPr>
          <a:xfrm>
            <a:off x="6545988" y="1752589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29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A33768B-BD1F-0B31-50EE-A3AEE917773C}"/>
              </a:ext>
            </a:extLst>
          </p:cNvPr>
          <p:cNvSpPr txBox="1"/>
          <p:nvPr/>
        </p:nvSpPr>
        <p:spPr>
          <a:xfrm>
            <a:off x="775941" y="3868450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4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7A5F6C4-8956-20FD-6710-4411FD1ECEDD}"/>
              </a:ext>
            </a:extLst>
          </p:cNvPr>
          <p:cNvSpPr txBox="1"/>
          <p:nvPr/>
        </p:nvSpPr>
        <p:spPr>
          <a:xfrm>
            <a:off x="3696728" y="3864839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67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28BA85D-3091-E0E8-E35A-FBDFE01F2964}"/>
              </a:ext>
            </a:extLst>
          </p:cNvPr>
          <p:cNvSpPr txBox="1"/>
          <p:nvPr/>
        </p:nvSpPr>
        <p:spPr>
          <a:xfrm>
            <a:off x="6517944" y="3874562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91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4A8183B-8345-AB95-603D-35D92ADCEEAB}"/>
              </a:ext>
            </a:extLst>
          </p:cNvPr>
          <p:cNvSpPr txBox="1"/>
          <p:nvPr/>
        </p:nvSpPr>
        <p:spPr>
          <a:xfrm>
            <a:off x="809798" y="5896414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0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B430A9A-B23C-DD60-B9D5-8616D57ED955}"/>
              </a:ext>
            </a:extLst>
          </p:cNvPr>
          <p:cNvSpPr txBox="1"/>
          <p:nvPr/>
        </p:nvSpPr>
        <p:spPr>
          <a:xfrm>
            <a:off x="3673277" y="5896413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2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7482CA0-7643-C7A4-DAD4-84041C61C648}"/>
              </a:ext>
            </a:extLst>
          </p:cNvPr>
          <p:cNvSpPr txBox="1"/>
          <p:nvPr/>
        </p:nvSpPr>
        <p:spPr>
          <a:xfrm>
            <a:off x="6537833" y="5896884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99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E337108-B9D2-10C7-05B8-BA515A4F6963}"/>
              </a:ext>
            </a:extLst>
          </p:cNvPr>
          <p:cNvSpPr txBox="1"/>
          <p:nvPr/>
        </p:nvSpPr>
        <p:spPr>
          <a:xfrm>
            <a:off x="1687498" y="5108450"/>
            <a:ext cx="5249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0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A060556C-D7DB-04FA-96F0-7A2C6B3B2186}"/>
              </a:ext>
            </a:extLst>
          </p:cNvPr>
          <p:cNvSpPr txBox="1"/>
          <p:nvPr/>
        </p:nvSpPr>
        <p:spPr>
          <a:xfrm>
            <a:off x="1640887" y="5897913"/>
            <a:ext cx="4962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0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592F866-C587-D39E-CE03-25FA8FD151B5}"/>
              </a:ext>
            </a:extLst>
          </p:cNvPr>
          <p:cNvSpPr txBox="1"/>
          <p:nvPr/>
        </p:nvSpPr>
        <p:spPr>
          <a:xfrm>
            <a:off x="4517402" y="4967407"/>
            <a:ext cx="5354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63D17D0-EEB1-074A-618B-EF2A21D4A8EC}"/>
              </a:ext>
            </a:extLst>
          </p:cNvPr>
          <p:cNvSpPr txBox="1"/>
          <p:nvPr/>
        </p:nvSpPr>
        <p:spPr>
          <a:xfrm>
            <a:off x="5322088" y="6016806"/>
            <a:ext cx="5348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6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FC37F04-C20F-F533-A803-B501B4B1DD5B}"/>
              </a:ext>
            </a:extLst>
          </p:cNvPr>
          <p:cNvSpPr txBox="1"/>
          <p:nvPr/>
        </p:nvSpPr>
        <p:spPr>
          <a:xfrm>
            <a:off x="2403443" y="3361980"/>
            <a:ext cx="561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0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233D2D0-F60C-E243-61E6-D8A12C7299A3}"/>
              </a:ext>
            </a:extLst>
          </p:cNvPr>
          <p:cNvSpPr txBox="1"/>
          <p:nvPr/>
        </p:nvSpPr>
        <p:spPr>
          <a:xfrm>
            <a:off x="2188500" y="3872533"/>
            <a:ext cx="5439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0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DF888DC-9854-8EAE-C8F9-47FEF745BB18}"/>
              </a:ext>
            </a:extLst>
          </p:cNvPr>
          <p:cNvSpPr txBox="1"/>
          <p:nvPr/>
        </p:nvSpPr>
        <p:spPr>
          <a:xfrm>
            <a:off x="5384652" y="3361980"/>
            <a:ext cx="4689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7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B5874D8-E8B9-4774-04A7-ACEE475ECA64}"/>
              </a:ext>
            </a:extLst>
          </p:cNvPr>
          <p:cNvSpPr txBox="1"/>
          <p:nvPr/>
        </p:nvSpPr>
        <p:spPr>
          <a:xfrm>
            <a:off x="4899878" y="3774175"/>
            <a:ext cx="5213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5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35490A2-EBEC-D4B8-A209-12B61EC36A06}"/>
              </a:ext>
            </a:extLst>
          </p:cNvPr>
          <p:cNvSpPr txBox="1"/>
          <p:nvPr/>
        </p:nvSpPr>
        <p:spPr>
          <a:xfrm>
            <a:off x="8152470" y="5422370"/>
            <a:ext cx="575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383F237-139C-1E6A-533D-2D62CF12000D}"/>
              </a:ext>
            </a:extLst>
          </p:cNvPr>
          <p:cNvSpPr txBox="1"/>
          <p:nvPr/>
        </p:nvSpPr>
        <p:spPr>
          <a:xfrm>
            <a:off x="8297979" y="5878307"/>
            <a:ext cx="4716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5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4AAAC92-3CE5-1B0F-82CA-070C28A32973}"/>
              </a:ext>
            </a:extLst>
          </p:cNvPr>
          <p:cNvSpPr txBox="1"/>
          <p:nvPr/>
        </p:nvSpPr>
        <p:spPr>
          <a:xfrm>
            <a:off x="8210037" y="3361980"/>
            <a:ext cx="5229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7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CCD1CB61-ED0C-7C12-CB36-A716D08E79B5}"/>
              </a:ext>
            </a:extLst>
          </p:cNvPr>
          <p:cNvSpPr txBox="1"/>
          <p:nvPr/>
        </p:nvSpPr>
        <p:spPr>
          <a:xfrm>
            <a:off x="7888894" y="3885726"/>
            <a:ext cx="4915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5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114DB46-CC9F-2F9A-6BA9-AB6900182BF1}"/>
              </a:ext>
            </a:extLst>
          </p:cNvPr>
          <p:cNvSpPr txBox="1"/>
          <p:nvPr/>
        </p:nvSpPr>
        <p:spPr>
          <a:xfrm>
            <a:off x="4645475" y="1095573"/>
            <a:ext cx="4917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1C06CDB-4755-6FDF-9A5B-5AF12C768064}"/>
              </a:ext>
            </a:extLst>
          </p:cNvPr>
          <p:cNvSpPr txBox="1"/>
          <p:nvPr/>
        </p:nvSpPr>
        <p:spPr>
          <a:xfrm>
            <a:off x="5097435" y="1685020"/>
            <a:ext cx="5500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189BBCFE-9881-5B68-F6FF-40F4E03E5D78}"/>
              </a:ext>
            </a:extLst>
          </p:cNvPr>
          <p:cNvSpPr txBox="1"/>
          <p:nvPr/>
        </p:nvSpPr>
        <p:spPr>
          <a:xfrm>
            <a:off x="7379538" y="820128"/>
            <a:ext cx="5325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98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C482801-5672-17FF-0934-D53F5A2B2278}"/>
              </a:ext>
            </a:extLst>
          </p:cNvPr>
          <p:cNvSpPr txBox="1"/>
          <p:nvPr/>
        </p:nvSpPr>
        <p:spPr>
          <a:xfrm>
            <a:off x="8182465" y="1917057"/>
            <a:ext cx="5781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0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5A347BD-8EE3-0D8D-BC83-1D68BBAEBAAF}"/>
              </a:ext>
            </a:extLst>
          </p:cNvPr>
          <p:cNvSpPr txBox="1"/>
          <p:nvPr/>
        </p:nvSpPr>
        <p:spPr>
          <a:xfrm>
            <a:off x="1772579" y="996069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0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169EE25-C531-5754-C3E3-9AC4A5D144EE}"/>
              </a:ext>
            </a:extLst>
          </p:cNvPr>
          <p:cNvSpPr txBox="1"/>
          <p:nvPr/>
        </p:nvSpPr>
        <p:spPr>
          <a:xfrm>
            <a:off x="1568204" y="1677854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02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01CBCA99-8EB0-9E33-6E8C-14D1533A6202}"/>
              </a:ext>
            </a:extLst>
          </p:cNvPr>
          <p:cNvCxnSpPr/>
          <p:nvPr/>
        </p:nvCxnSpPr>
        <p:spPr>
          <a:xfrm>
            <a:off x="1962918" y="1165684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71D4446D-C592-3962-60F0-6E9F7543085B}"/>
              </a:ext>
            </a:extLst>
          </p:cNvPr>
          <p:cNvCxnSpPr/>
          <p:nvPr/>
        </p:nvCxnSpPr>
        <p:spPr>
          <a:xfrm flipV="1">
            <a:off x="1777957" y="1541773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2C6159A8-196E-3CE8-D9E3-5F4BD7C64167}"/>
              </a:ext>
            </a:extLst>
          </p:cNvPr>
          <p:cNvCxnSpPr/>
          <p:nvPr/>
        </p:nvCxnSpPr>
        <p:spPr>
          <a:xfrm>
            <a:off x="1904285" y="5266501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B513C9FE-B365-93E0-C817-B66DEED2FA46}"/>
              </a:ext>
            </a:extLst>
          </p:cNvPr>
          <p:cNvCxnSpPr/>
          <p:nvPr/>
        </p:nvCxnSpPr>
        <p:spPr>
          <a:xfrm flipH="1" flipV="1">
            <a:off x="1833011" y="5760141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D322A50D-5DB5-6C23-9BC1-91EB0C6B771F}"/>
              </a:ext>
            </a:extLst>
          </p:cNvPr>
          <p:cNvCxnSpPr/>
          <p:nvPr/>
        </p:nvCxnSpPr>
        <p:spPr>
          <a:xfrm rot="5400000">
            <a:off x="8258609" y="5904168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CF94509A-D7B2-9E45-8E44-4587575CA5CB}"/>
              </a:ext>
            </a:extLst>
          </p:cNvPr>
          <p:cNvCxnSpPr/>
          <p:nvPr/>
        </p:nvCxnSpPr>
        <p:spPr>
          <a:xfrm flipV="1">
            <a:off x="5589509" y="581959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A9704BCF-7DA9-F35F-4CE4-F023DC9213FE}"/>
              </a:ext>
            </a:extLst>
          </p:cNvPr>
          <p:cNvCxnSpPr/>
          <p:nvPr/>
        </p:nvCxnSpPr>
        <p:spPr>
          <a:xfrm>
            <a:off x="4761506" y="5166534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315672C8-C23D-ECB9-C59A-EED953F52DCF}"/>
              </a:ext>
            </a:extLst>
          </p:cNvPr>
          <p:cNvCxnSpPr/>
          <p:nvPr/>
        </p:nvCxnSpPr>
        <p:spPr>
          <a:xfrm flipV="1">
            <a:off x="8421214" y="1768206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01F368C2-DAB0-6006-09AA-7DC2EF66CDF9}"/>
              </a:ext>
            </a:extLst>
          </p:cNvPr>
          <p:cNvCxnSpPr/>
          <p:nvPr/>
        </p:nvCxnSpPr>
        <p:spPr>
          <a:xfrm>
            <a:off x="7618081" y="101158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4F884BE-1F1D-82E6-AAAB-ACB24AC88D81}"/>
              </a:ext>
            </a:extLst>
          </p:cNvPr>
          <p:cNvSpPr txBox="1"/>
          <p:nvPr/>
        </p:nvSpPr>
        <p:spPr>
          <a:xfrm>
            <a:off x="9158756" y="1773277"/>
            <a:ext cx="2656024" cy="3191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 smtClean="0"/>
              <a:t>SUPPLEMENTARY FIGURE 1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aplan-Meier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 for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CGA bladder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ncer data;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erall Survival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OS) o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2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hole 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50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hole 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OS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D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hole 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19438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FE0FF91-E0DE-DFDB-AF55-2D542E0BD286}"/>
              </a:ext>
            </a:extLst>
          </p:cNvPr>
          <p:cNvGrpSpPr/>
          <p:nvPr/>
        </p:nvGrpSpPr>
        <p:grpSpPr>
          <a:xfrm>
            <a:off x="230765" y="738542"/>
            <a:ext cx="9186465" cy="2587008"/>
            <a:chOff x="20068" y="359714"/>
            <a:chExt cx="9186465" cy="2587008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DD3AF40-DDA6-FFF3-DCE5-1421FFADBC36}"/>
                </a:ext>
              </a:extLst>
            </p:cNvPr>
            <p:cNvSpPr txBox="1"/>
            <p:nvPr/>
          </p:nvSpPr>
          <p:spPr>
            <a:xfrm>
              <a:off x="20068" y="359714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5A65083-B8E4-D2D7-F7A8-46CEE9CAE7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75705" y="866625"/>
              <a:ext cx="2865414" cy="201988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A5D3F9B-3156-EEB5-9B49-0A58E307FA0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41119" y="866625"/>
              <a:ext cx="2865414" cy="2019882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4C5571C-000E-8BE6-6E8A-41144F1ABD3D}"/>
                </a:ext>
              </a:extLst>
            </p:cNvPr>
            <p:cNvSpPr txBox="1"/>
            <p:nvPr/>
          </p:nvSpPr>
          <p:spPr>
            <a:xfrm>
              <a:off x="3833321" y="2292643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21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E12FCA9-F3B1-18C5-FC77-1B3736C62E20}"/>
                </a:ext>
              </a:extLst>
            </p:cNvPr>
            <p:cNvSpPr txBox="1"/>
            <p:nvPr/>
          </p:nvSpPr>
          <p:spPr>
            <a:xfrm>
              <a:off x="6695937" y="2292016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68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E1BA276-72F3-D26D-F661-65F5A93D78CB}"/>
                </a:ext>
              </a:extLst>
            </p:cNvPr>
            <p:cNvSpPr txBox="1"/>
            <p:nvPr/>
          </p:nvSpPr>
          <p:spPr>
            <a:xfrm>
              <a:off x="7389360" y="1241576"/>
              <a:ext cx="49170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18E74DD-D2B7-838E-2F86-759A8B735F7E}"/>
                </a:ext>
              </a:extLst>
            </p:cNvPr>
            <p:cNvSpPr txBox="1"/>
            <p:nvPr/>
          </p:nvSpPr>
          <p:spPr>
            <a:xfrm>
              <a:off x="8520899" y="1823994"/>
              <a:ext cx="466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3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59A763C-2A97-DA7D-62CD-EDF065D6A5D7}"/>
                </a:ext>
              </a:extLst>
            </p:cNvPr>
            <p:cNvSpPr txBox="1"/>
            <p:nvPr/>
          </p:nvSpPr>
          <p:spPr>
            <a:xfrm>
              <a:off x="5493728" y="1443456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3A56D16-2785-C08F-E744-78D69F7F21EA}"/>
                </a:ext>
              </a:extLst>
            </p:cNvPr>
            <p:cNvSpPr txBox="1"/>
            <p:nvPr/>
          </p:nvSpPr>
          <p:spPr>
            <a:xfrm>
              <a:off x="5612709" y="2062620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9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5FB4B41-4992-08FD-9F93-5E3EC728A7D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89291" y="866625"/>
              <a:ext cx="2861781" cy="2017321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DDC2D86-E233-366A-0208-DF5DC3812367}"/>
                </a:ext>
              </a:extLst>
            </p:cNvPr>
            <p:cNvSpPr txBox="1"/>
            <p:nvPr/>
          </p:nvSpPr>
          <p:spPr>
            <a:xfrm>
              <a:off x="950545" y="2284521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28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0769F79-C4FB-34E9-5CDF-16818B97B2B6}"/>
                </a:ext>
              </a:extLst>
            </p:cNvPr>
            <p:cNvSpPr txBox="1"/>
            <p:nvPr/>
          </p:nvSpPr>
          <p:spPr>
            <a:xfrm>
              <a:off x="2610952" y="1435334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BB91829-77AB-B940-3FFE-631F150AE4A3}"/>
                </a:ext>
              </a:extLst>
            </p:cNvPr>
            <p:cNvSpPr txBox="1"/>
            <p:nvPr/>
          </p:nvSpPr>
          <p:spPr>
            <a:xfrm>
              <a:off x="2729933" y="2054498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4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1867DCB-A6EA-29AC-DFA9-E2686DC45990}"/>
                </a:ext>
              </a:extLst>
            </p:cNvPr>
            <p:cNvSpPr txBox="1"/>
            <p:nvPr/>
          </p:nvSpPr>
          <p:spPr>
            <a:xfrm rot="16200000">
              <a:off x="-773578" y="1592344"/>
              <a:ext cx="24625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D21 (</a:t>
              </a:r>
              <a:r>
                <a:rPr lang="en-US" sz="800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MN_1748578</a:t>
              </a:r>
              <a:r>
                <a:rPr lang="en-US" sz="10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r>
                <a:rPr lang="en-US" sz="10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0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</a:t>
              </a:r>
              <a:r>
                <a:rPr lang="en-US" sz="10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4FCCA8CE-2118-5A6C-FC46-D52BA77321A7}"/>
                </a:ext>
              </a:extLst>
            </p:cNvPr>
            <p:cNvSpPr txBox="1"/>
            <p:nvPr/>
          </p:nvSpPr>
          <p:spPr>
            <a:xfrm>
              <a:off x="1288165" y="667491"/>
              <a:ext cx="17187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 cohort-GSE4807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CB617A6-087C-7AE9-D473-454D9EA0C91C}"/>
                </a:ext>
              </a:extLst>
            </p:cNvPr>
            <p:cNvSpPr txBox="1"/>
            <p:nvPr/>
          </p:nvSpPr>
          <p:spPr>
            <a:xfrm>
              <a:off x="4024920" y="667491"/>
              <a:ext cx="20441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w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hort-GSE48075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E37C94A-5ECE-157F-2B67-D36BF522EFBE}"/>
                </a:ext>
              </a:extLst>
            </p:cNvPr>
            <p:cNvSpPr txBox="1"/>
            <p:nvPr/>
          </p:nvSpPr>
          <p:spPr>
            <a:xfrm>
              <a:off x="6891760" y="670644"/>
              <a:ext cx="20730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High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hort-GSE48075</a:t>
              </a:r>
            </a:p>
          </p:txBody>
        </p:sp>
      </p:grpSp>
      <p:pic>
        <p:nvPicPr>
          <p:cNvPr id="22" name="Picture 21">
            <a:extLst>
              <a:ext uri="{FF2B5EF4-FFF2-40B4-BE49-F238E27FC236}">
                <a16:creationId xmlns:a16="http://schemas.microsoft.com/office/drawing/2014/main" id="{CC476D02-6A38-C131-5D7F-91F7FF42DD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49946" y="1366306"/>
            <a:ext cx="701210" cy="22808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3A34C2E5-CF19-B801-9F17-EDC38D2D452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97408" y="1361066"/>
            <a:ext cx="719162" cy="242048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8996193F-2875-7B89-F82A-1A04DE612F6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57811" y="1366306"/>
            <a:ext cx="699960" cy="228083"/>
          </a:xfrm>
          <a:prstGeom prst="rect">
            <a:avLst/>
          </a:prstGeom>
        </p:spPr>
      </p:pic>
      <p:grpSp>
        <p:nvGrpSpPr>
          <p:cNvPr id="25" name="Group 24">
            <a:extLst>
              <a:ext uri="{FF2B5EF4-FFF2-40B4-BE49-F238E27FC236}">
                <a16:creationId xmlns:a16="http://schemas.microsoft.com/office/drawing/2014/main" id="{6AE32BE2-F1BF-41DF-B1D1-D615C180F9CB}"/>
              </a:ext>
            </a:extLst>
          </p:cNvPr>
          <p:cNvGrpSpPr/>
          <p:nvPr/>
        </p:nvGrpSpPr>
        <p:grpSpPr>
          <a:xfrm>
            <a:off x="234319" y="3434063"/>
            <a:ext cx="9212627" cy="2261260"/>
            <a:chOff x="1012973" y="3332800"/>
            <a:chExt cx="9212627" cy="2261260"/>
          </a:xfrm>
        </p:grpSpPr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1CE8DCE-D507-BCA2-C2B9-9DCFB215C3F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329298" y="3552404"/>
              <a:ext cx="2896302" cy="2041656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7E59062C-CE6D-D05C-2594-BF0215B9488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472917" y="3552404"/>
              <a:ext cx="2896303" cy="2041656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9DB1812-DBA1-9E3A-5CD3-065BCAA69978}"/>
                </a:ext>
              </a:extLst>
            </p:cNvPr>
            <p:cNvSpPr txBox="1"/>
            <p:nvPr/>
          </p:nvSpPr>
          <p:spPr>
            <a:xfrm>
              <a:off x="4822672" y="4958266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153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726E9CF9-0A77-5F4C-91D3-BCA8660DF77F}"/>
                </a:ext>
              </a:extLst>
            </p:cNvPr>
            <p:cNvSpPr txBox="1"/>
            <p:nvPr/>
          </p:nvSpPr>
          <p:spPr>
            <a:xfrm>
              <a:off x="7685288" y="4957639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48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D70C783-FD46-65DB-5BBA-17F74218BDDE}"/>
                </a:ext>
              </a:extLst>
            </p:cNvPr>
            <p:cNvSpPr txBox="1"/>
            <p:nvPr/>
          </p:nvSpPr>
          <p:spPr>
            <a:xfrm>
              <a:off x="6719751" y="4354126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87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E04B1FC-1F1D-530E-3D6E-34413E0363AC}"/>
                </a:ext>
              </a:extLst>
            </p:cNvPr>
            <p:cNvSpPr txBox="1"/>
            <p:nvPr/>
          </p:nvSpPr>
          <p:spPr>
            <a:xfrm>
              <a:off x="6218272" y="4079373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51</a:t>
              </a:r>
            </a:p>
          </p:txBody>
        </p: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B20EB62F-439D-2C60-95B7-9E52BEB339AC}"/>
                </a:ext>
              </a:extLst>
            </p:cNvPr>
            <p:cNvCxnSpPr/>
            <p:nvPr/>
          </p:nvCxnSpPr>
          <p:spPr>
            <a:xfrm flipV="1">
              <a:off x="6483079" y="3732551"/>
              <a:ext cx="0" cy="3468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C4AA6C3D-2CC3-0BC0-76B6-24EAE8A5D847}"/>
                </a:ext>
              </a:extLst>
            </p:cNvPr>
            <p:cNvCxnSpPr/>
            <p:nvPr/>
          </p:nvCxnSpPr>
          <p:spPr>
            <a:xfrm flipV="1">
              <a:off x="6969082" y="4007304"/>
              <a:ext cx="0" cy="3468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B720630-9560-9F98-8420-E0BC2C137026}"/>
                </a:ext>
              </a:extLst>
            </p:cNvPr>
            <p:cNvSpPr txBox="1"/>
            <p:nvPr/>
          </p:nvSpPr>
          <p:spPr>
            <a:xfrm>
              <a:off x="9567184" y="4162002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5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86623F7-FA6C-C769-07F1-2834C664C21B}"/>
                </a:ext>
              </a:extLst>
            </p:cNvPr>
            <p:cNvSpPr txBox="1"/>
            <p:nvPr/>
          </p:nvSpPr>
          <p:spPr>
            <a:xfrm>
              <a:off x="9037827" y="4035452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87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D164E918-D4A6-DD0C-9406-9D76E613391E}"/>
                </a:ext>
              </a:extLst>
            </p:cNvPr>
            <p:cNvCxnSpPr/>
            <p:nvPr/>
          </p:nvCxnSpPr>
          <p:spPr>
            <a:xfrm flipV="1">
              <a:off x="9302634" y="3688630"/>
              <a:ext cx="0" cy="3468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36">
              <a:extLst>
                <a:ext uri="{FF2B5EF4-FFF2-40B4-BE49-F238E27FC236}">
                  <a16:creationId xmlns:a16="http://schemas.microsoft.com/office/drawing/2014/main" id="{D477D78C-B411-DFDA-2EAD-34F87126FB81}"/>
                </a:ext>
              </a:extLst>
            </p:cNvPr>
            <p:cNvCxnSpPr/>
            <p:nvPr/>
          </p:nvCxnSpPr>
          <p:spPr>
            <a:xfrm flipV="1">
              <a:off x="9816515" y="3815180"/>
              <a:ext cx="0" cy="3468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18D41CEE-B7D5-D451-E3EB-40185480B5F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542492" y="3549843"/>
              <a:ext cx="2896303" cy="2041656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C9EB69B5-DD0A-0602-A922-2730F90C010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439550" y="4935957"/>
              <a:ext cx="701210" cy="228083"/>
            </a:xfrm>
            <a:prstGeom prst="rect">
              <a:avLst/>
            </a:prstGeom>
          </p:spPr>
        </p:pic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1DA2340C-1D45-81AB-846F-2E42924C33B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287012" y="4930717"/>
              <a:ext cx="719162" cy="242048"/>
            </a:xfrm>
            <a:prstGeom prst="rect">
              <a:avLst/>
            </a:prstGeom>
          </p:spPr>
        </p:pic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5699042F-A1E8-46B9-315A-6214059215F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47415" y="4935957"/>
              <a:ext cx="699960" cy="228083"/>
            </a:xfrm>
            <a:prstGeom prst="rect">
              <a:avLst/>
            </a:prstGeom>
          </p:spPr>
        </p:pic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F60CD37-667C-92BC-1648-583FAF88E07F}"/>
                </a:ext>
              </a:extLst>
            </p:cNvPr>
            <p:cNvSpPr txBox="1"/>
            <p:nvPr/>
          </p:nvSpPr>
          <p:spPr>
            <a:xfrm>
              <a:off x="1012973" y="3332800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400DEF38-5A19-E34F-4A2A-745C05B2642B}"/>
                </a:ext>
              </a:extLst>
            </p:cNvPr>
            <p:cNvSpPr txBox="1"/>
            <p:nvPr/>
          </p:nvSpPr>
          <p:spPr>
            <a:xfrm rot="16200000">
              <a:off x="631752" y="4288649"/>
              <a:ext cx="16305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D21</a:t>
              </a:r>
              <a:r>
                <a:rPr lang="en-US" sz="10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0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</a:t>
              </a:r>
              <a:r>
                <a:rPr lang="en-US" sz="10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7C5C6FF-E818-64E4-1968-42C18D3D541A}"/>
                </a:ext>
              </a:extLst>
            </p:cNvPr>
            <p:cNvSpPr txBox="1"/>
            <p:nvPr/>
          </p:nvSpPr>
          <p:spPr>
            <a:xfrm>
              <a:off x="2155804" y="3332800"/>
              <a:ext cx="194316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 cohort-E-MTAB-432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B8BB2A34-FED7-58C2-F515-57EDA7A61C68}"/>
                </a:ext>
              </a:extLst>
            </p:cNvPr>
            <p:cNvSpPr txBox="1"/>
            <p:nvPr/>
          </p:nvSpPr>
          <p:spPr>
            <a:xfrm>
              <a:off x="4892559" y="3332800"/>
              <a:ext cx="23038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w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hort-E-MTAB-4321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EE89837-624E-8660-1757-8A2065F22DCF}"/>
                </a:ext>
              </a:extLst>
            </p:cNvPr>
            <p:cNvSpPr txBox="1"/>
            <p:nvPr/>
          </p:nvSpPr>
          <p:spPr>
            <a:xfrm>
              <a:off x="7759399" y="3335953"/>
              <a:ext cx="233269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High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hort-E-MTAB-432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A19EC9DD-A770-9B5C-B31C-1ACE6880B021}"/>
                </a:ext>
              </a:extLst>
            </p:cNvPr>
            <p:cNvSpPr txBox="1"/>
            <p:nvPr/>
          </p:nvSpPr>
          <p:spPr>
            <a:xfrm>
              <a:off x="1857466" y="4958195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131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7C1EF2D-7B40-FDB0-FFDF-2CA394207D11}"/>
                </a:ext>
              </a:extLst>
            </p:cNvPr>
            <p:cNvSpPr txBox="1"/>
            <p:nvPr/>
          </p:nvSpPr>
          <p:spPr>
            <a:xfrm>
              <a:off x="3754545" y="4211650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38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A5C49D3-2F92-2FFC-C79E-502C66B307FA}"/>
                </a:ext>
              </a:extLst>
            </p:cNvPr>
            <p:cNvSpPr txBox="1"/>
            <p:nvPr/>
          </p:nvSpPr>
          <p:spPr>
            <a:xfrm>
              <a:off x="3253066" y="4064312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38</a:t>
              </a:r>
            </a:p>
          </p:txBody>
        </p:sp>
        <p:cxnSp>
          <p:nvCxnSpPr>
            <p:cNvPr id="50" name="Straight Arrow Connector 49">
              <a:extLst>
                <a:ext uri="{FF2B5EF4-FFF2-40B4-BE49-F238E27FC236}">
                  <a16:creationId xmlns:a16="http://schemas.microsoft.com/office/drawing/2014/main" id="{21AC0747-B855-78F0-CC38-52D8C833852A}"/>
                </a:ext>
              </a:extLst>
            </p:cNvPr>
            <p:cNvCxnSpPr/>
            <p:nvPr/>
          </p:nvCxnSpPr>
          <p:spPr>
            <a:xfrm flipV="1">
              <a:off x="3517873" y="3717490"/>
              <a:ext cx="0" cy="3468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>
              <a:extLst>
                <a:ext uri="{FF2B5EF4-FFF2-40B4-BE49-F238E27FC236}">
                  <a16:creationId xmlns:a16="http://schemas.microsoft.com/office/drawing/2014/main" id="{8A0658A5-F588-C54D-32E3-72B1E31DCDB9}"/>
                </a:ext>
              </a:extLst>
            </p:cNvPr>
            <p:cNvCxnSpPr/>
            <p:nvPr/>
          </p:nvCxnSpPr>
          <p:spPr>
            <a:xfrm flipV="1">
              <a:off x="4003876" y="3864828"/>
              <a:ext cx="0" cy="34682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7321E55-0956-A024-CDE4-F04963246A5C}"/>
              </a:ext>
            </a:extLst>
          </p:cNvPr>
          <p:cNvSpPr txBox="1"/>
          <p:nvPr/>
        </p:nvSpPr>
        <p:spPr>
          <a:xfrm>
            <a:off x="9509958" y="1823316"/>
            <a:ext cx="2435431" cy="3191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/>
              <a:t>SUPPLEMENTARY FIGURE 2. </a:t>
            </a:r>
            <a:endParaRPr lang="en-US" sz="1400" b="1" dirty="0" smtClean="0"/>
          </a:p>
          <a:p>
            <a:pPr lvl="0"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Kaplan-Meier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 for GEO-GSE48075 bladder cancer data; Overall Survival (OS) of </a:t>
            </a:r>
            <a:r>
              <a:rPr lang="en-US" sz="1400" i="1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21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cohort and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aplan-Meier analysis for E-MTAB-4321 bladder cancer data;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21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whole cohort,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 and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endParaRPr lang="en-US" sz="1400" dirty="0" smtClean="0">
              <a:solidFill>
                <a:prstClr val="black"/>
              </a:solidFill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1542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288E01B-FE80-2EC5-A8DF-A135CA8BAE6C}"/>
              </a:ext>
            </a:extLst>
          </p:cNvPr>
          <p:cNvGrpSpPr/>
          <p:nvPr/>
        </p:nvGrpSpPr>
        <p:grpSpPr>
          <a:xfrm>
            <a:off x="282098" y="749655"/>
            <a:ext cx="9078438" cy="2564353"/>
            <a:chOff x="1379866" y="56970"/>
            <a:chExt cx="9078438" cy="256435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C5460F79-B5FE-9FC5-50B3-0C9EFD7F822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25980" y="599564"/>
              <a:ext cx="2868077" cy="202175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6B66CC9-12CE-E11A-34C7-570FE10CBF4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44924" y="626357"/>
              <a:ext cx="2813380" cy="1983202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7928AB6-8DF4-B51E-1B32-A4CC0D4C3D3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83902" y="592774"/>
              <a:ext cx="2861022" cy="201678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9B4EAF9-628F-2789-DE91-849997012265}"/>
                </a:ext>
              </a:extLst>
            </p:cNvPr>
            <p:cNvSpPr txBox="1"/>
            <p:nvPr/>
          </p:nvSpPr>
          <p:spPr>
            <a:xfrm>
              <a:off x="5070010" y="1990213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313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C745C5E-3035-F7AE-832A-0023B4B04A10}"/>
                </a:ext>
              </a:extLst>
            </p:cNvPr>
            <p:cNvSpPr txBox="1"/>
            <p:nvPr/>
          </p:nvSpPr>
          <p:spPr>
            <a:xfrm>
              <a:off x="7932626" y="1989586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51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D27DFE3-3EF5-2409-FC79-C68B6FEB7BF0}"/>
                </a:ext>
              </a:extLst>
            </p:cNvPr>
            <p:cNvSpPr txBox="1"/>
            <p:nvPr/>
          </p:nvSpPr>
          <p:spPr>
            <a:xfrm>
              <a:off x="6291815" y="1468819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5E72E6F-76DA-D03D-BF35-6D29861BC9DE}"/>
                </a:ext>
              </a:extLst>
            </p:cNvPr>
            <p:cNvSpPr txBox="1"/>
            <p:nvPr/>
          </p:nvSpPr>
          <p:spPr>
            <a:xfrm>
              <a:off x="6882872" y="911896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E4CAB69-FF1C-DFDF-27C7-A37CB41F8496}"/>
                </a:ext>
              </a:extLst>
            </p:cNvPr>
            <p:cNvSpPr txBox="1"/>
            <p:nvPr/>
          </p:nvSpPr>
          <p:spPr>
            <a:xfrm>
              <a:off x="9767141" y="1457944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0E4597D-E861-F618-FEE6-B9C50BCB85ED}"/>
                </a:ext>
              </a:extLst>
            </p:cNvPr>
            <p:cNvSpPr txBox="1"/>
            <p:nvPr/>
          </p:nvSpPr>
          <p:spPr>
            <a:xfrm>
              <a:off x="9565076" y="954770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6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92428F6-98BE-E27A-8AE7-4B607C8991F2}"/>
                </a:ext>
              </a:extLst>
            </p:cNvPr>
            <p:cNvSpPr txBox="1"/>
            <p:nvPr/>
          </p:nvSpPr>
          <p:spPr>
            <a:xfrm>
              <a:off x="1379866" y="5697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E41A3DD-62E3-2EBB-C8B5-9EA41085DDF7}"/>
                </a:ext>
              </a:extLst>
            </p:cNvPr>
            <p:cNvSpPr txBox="1"/>
            <p:nvPr/>
          </p:nvSpPr>
          <p:spPr>
            <a:xfrm rot="16200000">
              <a:off x="826190" y="1335984"/>
              <a:ext cx="17363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AD50 (</a:t>
              </a:r>
              <a:r>
                <a:rPr lang="en-US" sz="6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38656_at)</a:t>
              </a:r>
              <a:r>
                <a:rPr lang="en-US" sz="8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800" b="1" i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RNA</a:t>
              </a:r>
              <a:r>
                <a:rPr lang="en-US" sz="800" b="1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Expressio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BF5E9AE-4A02-F92C-BC6D-2C78019798C6}"/>
                </a:ext>
              </a:extLst>
            </p:cNvPr>
            <p:cNvSpPr txBox="1"/>
            <p:nvPr/>
          </p:nvSpPr>
          <p:spPr>
            <a:xfrm>
              <a:off x="2403142" y="364747"/>
              <a:ext cx="17187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hole cohort-GSE31684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8DBDC32-13D7-B834-9BBB-CDE822DF32FC}"/>
                </a:ext>
              </a:extLst>
            </p:cNvPr>
            <p:cNvSpPr txBox="1"/>
            <p:nvPr/>
          </p:nvSpPr>
          <p:spPr>
            <a:xfrm>
              <a:off x="5139897" y="364747"/>
              <a:ext cx="207941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Low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hort-GSE31684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37622EA-34C4-7F13-8C6D-579FBAF43E16}"/>
                </a:ext>
              </a:extLst>
            </p:cNvPr>
            <p:cNvSpPr txBox="1"/>
            <p:nvPr/>
          </p:nvSpPr>
          <p:spPr>
            <a:xfrm>
              <a:off x="8006737" y="367900"/>
              <a:ext cx="210826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BB2</a:t>
              </a:r>
              <a:r>
                <a:rPr lang="en-US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High 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hort-GSE31684 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A579058-A526-9F65-D025-F00F7F74EDD7}"/>
                </a:ext>
              </a:extLst>
            </p:cNvPr>
            <p:cNvSpPr txBox="1"/>
            <p:nvPr/>
          </p:nvSpPr>
          <p:spPr>
            <a:xfrm>
              <a:off x="2104804" y="1990142"/>
              <a:ext cx="7982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= 0.916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C5F4BBD-5D3A-6C4A-1678-512316B62980}"/>
                </a:ext>
              </a:extLst>
            </p:cNvPr>
            <p:cNvSpPr txBox="1"/>
            <p:nvPr/>
          </p:nvSpPr>
          <p:spPr>
            <a:xfrm>
              <a:off x="3325401" y="1508424"/>
              <a:ext cx="4986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83D0234-F210-4B5C-F0C1-17822A2DD971}"/>
                </a:ext>
              </a:extLst>
            </p:cNvPr>
            <p:cNvSpPr txBox="1"/>
            <p:nvPr/>
          </p:nvSpPr>
          <p:spPr>
            <a:xfrm>
              <a:off x="3787097" y="1065101"/>
              <a:ext cx="52961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9</a:t>
              </a:r>
            </a:p>
          </p:txBody>
        </p:sp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0F1B92D-6FA2-47D0-BD6B-2E7130E9ABF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780251" y="2000572"/>
              <a:ext cx="692277" cy="208430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A964C3A8-D419-17CB-8846-9336648872E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619807" y="2008547"/>
              <a:ext cx="692277" cy="208430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D71C1DAE-2DAE-B261-B3B2-88DB17FC0D7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41579" y="2008547"/>
              <a:ext cx="692277" cy="208430"/>
            </a:xfrm>
            <a:prstGeom prst="rect">
              <a:avLst/>
            </a:prstGeom>
          </p:spPr>
        </p:pic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F0A14692-BC26-4513-E131-DED67F86ECC0}"/>
              </a:ext>
            </a:extLst>
          </p:cNvPr>
          <p:cNvGrpSpPr/>
          <p:nvPr/>
        </p:nvGrpSpPr>
        <p:grpSpPr>
          <a:xfrm>
            <a:off x="169534" y="3207112"/>
            <a:ext cx="9191002" cy="2642189"/>
            <a:chOff x="1147090" y="637278"/>
            <a:chExt cx="9051636" cy="2586221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A8137A0D-F089-3D70-663C-F64A4CF6F17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698670" y="1209658"/>
              <a:ext cx="2831522" cy="1995991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14946F5D-AE9A-0E9C-00D2-5A5D0ADA3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7366073" y="1208862"/>
              <a:ext cx="2832653" cy="1996788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3C7DDD8F-4235-DFF8-3086-9547033B0ED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506614" y="1204515"/>
              <a:ext cx="2864140" cy="2018984"/>
            </a:xfrm>
            <a:prstGeom prst="rect">
              <a:avLst/>
            </a:prstGeom>
          </p:spPr>
        </p:pic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8C594494-9072-1497-5111-A2F05FD8133B}"/>
                </a:ext>
              </a:extLst>
            </p:cNvPr>
            <p:cNvGrpSpPr/>
            <p:nvPr/>
          </p:nvGrpSpPr>
          <p:grpSpPr>
            <a:xfrm>
              <a:off x="1147090" y="637278"/>
              <a:ext cx="8838913" cy="2486084"/>
              <a:chOff x="157739" y="359713"/>
              <a:chExt cx="8838913" cy="2486084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12B6A90-F42C-5208-670E-C876C8F35DAA}"/>
                  </a:ext>
                </a:extLst>
              </p:cNvPr>
              <p:cNvSpPr txBox="1"/>
              <p:nvPr/>
            </p:nvSpPr>
            <p:spPr>
              <a:xfrm>
                <a:off x="157739" y="359713"/>
                <a:ext cx="309741" cy="3012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1C2F2F1-05A3-7A4C-26CF-2475515E8B1A}"/>
                  </a:ext>
                </a:extLst>
              </p:cNvPr>
              <p:cNvSpPr txBox="1"/>
              <p:nvPr/>
            </p:nvSpPr>
            <p:spPr>
              <a:xfrm>
                <a:off x="3863284" y="2292643"/>
                <a:ext cx="7982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0.092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C28FA9CA-E64E-45C6-331F-6C2D4B321609}"/>
                  </a:ext>
                </a:extLst>
              </p:cNvPr>
              <p:cNvSpPr txBox="1"/>
              <p:nvPr/>
            </p:nvSpPr>
            <p:spPr>
              <a:xfrm>
                <a:off x="6695937" y="2292643"/>
                <a:ext cx="7982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0.974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9C39D7CB-8561-1358-F961-9D086BEC954E}"/>
                  </a:ext>
                </a:extLst>
              </p:cNvPr>
              <p:cNvSpPr txBox="1"/>
              <p:nvPr/>
            </p:nvSpPr>
            <p:spPr>
              <a:xfrm>
                <a:off x="7793048" y="1248294"/>
                <a:ext cx="49170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2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D36104F-B6EF-D6FE-9437-F852AD819F5D}"/>
                  </a:ext>
                </a:extLst>
              </p:cNvPr>
              <p:cNvSpPr txBox="1"/>
              <p:nvPr/>
            </p:nvSpPr>
            <p:spPr>
              <a:xfrm>
                <a:off x="8530452" y="1981941"/>
                <a:ext cx="4662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4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A0347B53-74D7-CAE1-A0EE-108D7335DF33}"/>
                  </a:ext>
                </a:extLst>
              </p:cNvPr>
              <p:cNvSpPr txBox="1"/>
              <p:nvPr/>
            </p:nvSpPr>
            <p:spPr>
              <a:xfrm>
                <a:off x="5294231" y="1565604"/>
                <a:ext cx="4986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8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FC0EB3EB-C9A9-5258-ADD7-5A2E3AE5C534}"/>
                  </a:ext>
                </a:extLst>
              </p:cNvPr>
              <p:cNvSpPr txBox="1"/>
              <p:nvPr/>
            </p:nvSpPr>
            <p:spPr>
              <a:xfrm>
                <a:off x="5691332" y="2081975"/>
                <a:ext cx="5296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9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B27FDA9-8A0E-BCEF-DA9D-53DC3EC0EEF3}"/>
                  </a:ext>
                </a:extLst>
              </p:cNvPr>
              <p:cNvSpPr txBox="1"/>
              <p:nvPr/>
            </p:nvSpPr>
            <p:spPr>
              <a:xfrm>
                <a:off x="988448" y="2292643"/>
                <a:ext cx="79824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= 0.284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EF70395-6890-837A-12C0-057FD3FAD2A0}"/>
                  </a:ext>
                </a:extLst>
              </p:cNvPr>
              <p:cNvSpPr txBox="1"/>
              <p:nvPr/>
            </p:nvSpPr>
            <p:spPr>
              <a:xfrm>
                <a:off x="1606956" y="1329782"/>
                <a:ext cx="49866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30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1FC923A-8EDD-C949-B097-5B85E1068E18}"/>
                  </a:ext>
                </a:extLst>
              </p:cNvPr>
              <p:cNvSpPr txBox="1"/>
              <p:nvPr/>
            </p:nvSpPr>
            <p:spPr>
              <a:xfrm>
                <a:off x="2909761" y="2181709"/>
                <a:ext cx="5296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43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88EAD078-FC68-393B-3AF6-3651E84CC142}"/>
                  </a:ext>
                </a:extLst>
              </p:cNvPr>
              <p:cNvSpPr txBox="1"/>
              <p:nvPr/>
            </p:nvSpPr>
            <p:spPr>
              <a:xfrm rot="16200000">
                <a:off x="-427661" y="1720723"/>
                <a:ext cx="2022816" cy="227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i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RD1 (</a:t>
                </a:r>
                <a:r>
                  <a:rPr lang="en-US" sz="600" u="sng" dirty="0"/>
                  <a:t>ILMN_2074258</a:t>
                </a:r>
                <a:r>
                  <a:rPr lang="en-US" sz="900" b="1" i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 mRNA</a:t>
                </a:r>
                <a:r>
                  <a:rPr lang="en-US" sz="900" b="1" u="sng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84429C1-72D3-0E4F-DEA5-AE46172F6C0D}"/>
                  </a:ext>
                </a:extLst>
              </p:cNvPr>
              <p:cNvSpPr txBox="1"/>
              <p:nvPr/>
            </p:nvSpPr>
            <p:spPr>
              <a:xfrm>
                <a:off x="1288165" y="667491"/>
                <a:ext cx="171874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hole cohort-GSE48075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DB6F15C5-6335-7587-9309-B15A9CC9F8CD}"/>
                  </a:ext>
                </a:extLst>
              </p:cNvPr>
              <p:cNvSpPr txBox="1"/>
              <p:nvPr/>
            </p:nvSpPr>
            <p:spPr>
              <a:xfrm>
                <a:off x="4024920" y="667491"/>
                <a:ext cx="204414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RBB2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Low </a:t>
                </a:r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hort-GSE48075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323C1669-765A-4959-3137-635AEE0442D5}"/>
                  </a:ext>
                </a:extLst>
              </p:cNvPr>
              <p:cNvSpPr txBox="1"/>
              <p:nvPr/>
            </p:nvSpPr>
            <p:spPr>
              <a:xfrm>
                <a:off x="6891760" y="670644"/>
                <a:ext cx="207300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i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RBB2</a:t>
                </a:r>
                <a:r>
                  <a:rPr lang="en-US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High </a:t>
                </a:r>
                <a:r>
                  <a:rPr lang="en-US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hort-GSE48075</a:t>
                </a:r>
              </a:p>
            </p:txBody>
          </p:sp>
        </p:grpSp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E024EE13-78DE-0057-DB74-C43927EF7E7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489414" y="1318461"/>
              <a:ext cx="732604" cy="215154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3E82D73F-1F7F-9D64-DE74-9CD949EAE12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328059" y="1318461"/>
              <a:ext cx="732604" cy="215154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EC07A63F-9749-8D6C-92AB-42B8094C9B1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656233" y="1308997"/>
              <a:ext cx="732604" cy="215154"/>
            </a:xfrm>
            <a:prstGeom prst="rect">
              <a:avLst/>
            </a:prstGeom>
          </p:spPr>
        </p:pic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D7321E55-0956-A024-CDE4-F04963246A5C}"/>
              </a:ext>
            </a:extLst>
          </p:cNvPr>
          <p:cNvSpPr txBox="1"/>
          <p:nvPr/>
        </p:nvSpPr>
        <p:spPr>
          <a:xfrm>
            <a:off x="9408178" y="1802944"/>
            <a:ext cx="2504381" cy="319157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/>
              <a:t>SUPPLEMENTARY FIGURE </a:t>
            </a:r>
            <a:r>
              <a:rPr lang="en-US" sz="1400" b="1" dirty="0" smtClean="0"/>
              <a:t>3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aplan-Meier analysis for GEO-GSE31684 bladder cancer data; Overall Survival (OS) of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50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NA expression in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hole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cohort and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400" b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aplan-Meier analysis for GEO-GSE48075 bladder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ncer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; 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RD1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NA expression in whole cohort,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 and </a:t>
            </a:r>
            <a:r>
              <a:rPr lang="en-US" sz="1400" i="1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endParaRPr lang="en-US" sz="1400" dirty="0" smtClean="0">
              <a:solidFill>
                <a:prstClr val="black"/>
              </a:solidFill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6377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0A832AD-A6DB-0F1B-F983-4F7BA18505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1608" y="4614845"/>
            <a:ext cx="2851595" cy="201014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7912DD9-23DD-C5D9-4B66-44A61666FF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6932" y="2598902"/>
            <a:ext cx="2846271" cy="200638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05C34D9-71FB-D5B8-D1D4-DA843964FA3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63283" y="581141"/>
            <a:ext cx="2862406" cy="201776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346183F-1803-BF55-202A-A5240DB1D9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00877" y="581141"/>
            <a:ext cx="2862406" cy="201776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EB294DC-25FF-A1D9-927F-E19514967F5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1608" y="581142"/>
            <a:ext cx="2862406" cy="20177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3C3E295-06D7-0EB6-943B-76F33DC56EF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60892" y="678353"/>
            <a:ext cx="953209" cy="33582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A08549B-F0EA-0709-AF59-02C3D9A5ABB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360892" y="2696867"/>
            <a:ext cx="951151" cy="32272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77CC4F3-82B0-2E12-6B52-092B48DDF74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60892" y="4709397"/>
            <a:ext cx="951151" cy="33509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0816B18-93DC-F810-EB40-213A1D5A4945}"/>
              </a:ext>
            </a:extLst>
          </p:cNvPr>
          <p:cNvSpPr txBox="1"/>
          <p:nvPr/>
        </p:nvSpPr>
        <p:spPr>
          <a:xfrm rot="16200000">
            <a:off x="-209613" y="1278950"/>
            <a:ext cx="12073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21/RAD50</a:t>
            </a:r>
            <a:endParaRPr lang="en-US" sz="1000" b="1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5DBB23D-EFF7-3621-DA81-77137CAA0BF4}"/>
              </a:ext>
            </a:extLst>
          </p:cNvPr>
          <p:cNvSpPr txBox="1"/>
          <p:nvPr/>
        </p:nvSpPr>
        <p:spPr>
          <a:xfrm rot="16200000">
            <a:off x="-209613" y="3298903"/>
            <a:ext cx="12073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21/BARD1</a:t>
            </a:r>
          </a:p>
          <a:p>
            <a:pPr algn="ctr"/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7B034BD-26BE-43BF-FF6B-6CA17C2E4277}"/>
              </a:ext>
            </a:extLst>
          </p:cNvPr>
          <p:cNvSpPr txBox="1"/>
          <p:nvPr/>
        </p:nvSpPr>
        <p:spPr>
          <a:xfrm rot="16200000">
            <a:off x="-212138" y="5318856"/>
            <a:ext cx="12073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50/BARD1</a:t>
            </a:r>
          </a:p>
          <a:p>
            <a:pPr algn="ctr"/>
            <a:r>
              <a:rPr lang="en-US" sz="1000" b="1" i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</a:t>
            </a:r>
            <a:r>
              <a:rPr lang="en-US" sz="10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BAD203F-419A-9F2E-3725-FDBA062C4FC0}"/>
              </a:ext>
            </a:extLst>
          </p:cNvPr>
          <p:cNvSpPr txBox="1"/>
          <p:nvPr/>
        </p:nvSpPr>
        <p:spPr>
          <a:xfrm>
            <a:off x="1620094" y="319532"/>
            <a:ext cx="10021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cohor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315D28-7902-A63D-1053-69838A688183}"/>
              </a:ext>
            </a:extLst>
          </p:cNvPr>
          <p:cNvSpPr txBox="1"/>
          <p:nvPr/>
        </p:nvSpPr>
        <p:spPr>
          <a:xfrm>
            <a:off x="4381709" y="323507"/>
            <a:ext cx="13628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ow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hor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41DAA00-D245-F7FB-0917-7BC698F78400}"/>
              </a:ext>
            </a:extLst>
          </p:cNvPr>
          <p:cNvSpPr txBox="1"/>
          <p:nvPr/>
        </p:nvSpPr>
        <p:spPr>
          <a:xfrm>
            <a:off x="7244683" y="323506"/>
            <a:ext cx="1391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RBB2</a:t>
            </a:r>
            <a:r>
              <a:rPr lang="en-US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High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hort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DA9D5754-22F9-77EB-1500-F57C67A9B4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81819" y="678353"/>
            <a:ext cx="953209" cy="33582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C14CAFB1-4125-0BD6-4B84-82FBE7B3100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44225" y="674840"/>
            <a:ext cx="953209" cy="335821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A83E4325-7ECF-D112-1820-86D6B863BCC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98078" y="2598902"/>
            <a:ext cx="2868004" cy="202170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1A9261C-40E9-A7AB-E9F6-BFE416BB797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81819" y="2692138"/>
            <a:ext cx="951151" cy="322724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2B73AD8-CAE9-A649-3529-B38AA5E09F8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66082" y="2598903"/>
            <a:ext cx="2859607" cy="201578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E0AFA5C2-FD61-BC31-17F1-23F863BB14D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144225" y="2696115"/>
            <a:ext cx="951151" cy="32272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8947C35-43CE-CBE2-2288-2C6D4D99D48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498077" y="4612687"/>
            <a:ext cx="2865206" cy="2006387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FEEEA0F6-BB3B-8FC2-1616-F188513739B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81818" y="4709397"/>
            <a:ext cx="951151" cy="33509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2FEEBF9A-B4DE-582E-E81B-5B681E1C03F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357635" y="4605288"/>
            <a:ext cx="2868054" cy="2013785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B0C9B4A-99D1-8FB4-DCC2-CD3E110620B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144225" y="4711257"/>
            <a:ext cx="951151" cy="33509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37BA5F24-455B-A6A8-550E-EF7CBA3725AE}"/>
              </a:ext>
            </a:extLst>
          </p:cNvPr>
          <p:cNvSpPr txBox="1"/>
          <p:nvPr/>
        </p:nvSpPr>
        <p:spPr>
          <a:xfrm>
            <a:off x="961488" y="37926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2093FEF-349E-5820-385C-BA91DAA1DC46}"/>
              </a:ext>
            </a:extLst>
          </p:cNvPr>
          <p:cNvSpPr txBox="1"/>
          <p:nvPr/>
        </p:nvSpPr>
        <p:spPr>
          <a:xfrm>
            <a:off x="3822229" y="37926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5841A5C-0E12-9424-9691-32305727B79A}"/>
              </a:ext>
            </a:extLst>
          </p:cNvPr>
          <p:cNvSpPr txBox="1"/>
          <p:nvPr/>
        </p:nvSpPr>
        <p:spPr>
          <a:xfrm>
            <a:off x="6691864" y="37926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EC7F506-3979-1FA6-947F-7C160B30E5C9}"/>
              </a:ext>
            </a:extLst>
          </p:cNvPr>
          <p:cNvSpPr txBox="1"/>
          <p:nvPr/>
        </p:nvSpPr>
        <p:spPr>
          <a:xfrm>
            <a:off x="959444" y="239313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76127F1-DDDD-FFC4-650D-2899483250FF}"/>
              </a:ext>
            </a:extLst>
          </p:cNvPr>
          <p:cNvSpPr txBox="1"/>
          <p:nvPr/>
        </p:nvSpPr>
        <p:spPr>
          <a:xfrm>
            <a:off x="3820185" y="239313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A27C3D7-5D00-0EB0-E886-D0A20BC4EAFF}"/>
              </a:ext>
            </a:extLst>
          </p:cNvPr>
          <p:cNvSpPr txBox="1"/>
          <p:nvPr/>
        </p:nvSpPr>
        <p:spPr>
          <a:xfrm>
            <a:off x="6689820" y="2393133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409278-6B0F-0B34-4191-337242A9DC24}"/>
              </a:ext>
            </a:extLst>
          </p:cNvPr>
          <p:cNvSpPr txBox="1"/>
          <p:nvPr/>
        </p:nvSpPr>
        <p:spPr>
          <a:xfrm>
            <a:off x="959444" y="4404740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77C300E-71D0-DA1B-BCF4-5DA4C58BA7A7}"/>
              </a:ext>
            </a:extLst>
          </p:cNvPr>
          <p:cNvSpPr txBox="1"/>
          <p:nvPr/>
        </p:nvSpPr>
        <p:spPr>
          <a:xfrm>
            <a:off x="3820185" y="4404740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7824C74-FBF6-A03C-E7C4-B76B4A40DEB1}"/>
              </a:ext>
            </a:extLst>
          </p:cNvPr>
          <p:cNvSpPr txBox="1"/>
          <p:nvPr/>
        </p:nvSpPr>
        <p:spPr>
          <a:xfrm>
            <a:off x="6689820" y="4404740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4B53155-BFFE-A153-8DB4-944E693B3A80}"/>
              </a:ext>
            </a:extLst>
          </p:cNvPr>
          <p:cNvSpPr txBox="1"/>
          <p:nvPr/>
        </p:nvSpPr>
        <p:spPr>
          <a:xfrm>
            <a:off x="920975" y="1885758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47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21B5D4A-BEBA-A616-B569-26ED1E69B74D}"/>
              </a:ext>
            </a:extLst>
          </p:cNvPr>
          <p:cNvSpPr txBox="1"/>
          <p:nvPr/>
        </p:nvSpPr>
        <p:spPr>
          <a:xfrm>
            <a:off x="3819977" y="1885132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54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BEBCD64-D86C-A1A3-5C2E-C354EBD732C1}"/>
              </a:ext>
            </a:extLst>
          </p:cNvPr>
          <p:cNvSpPr txBox="1"/>
          <p:nvPr/>
        </p:nvSpPr>
        <p:spPr>
          <a:xfrm>
            <a:off x="6689820" y="1885757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545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49752D8-345C-8E32-600B-4300FC7484AA}"/>
              </a:ext>
            </a:extLst>
          </p:cNvPr>
          <p:cNvSpPr txBox="1"/>
          <p:nvPr/>
        </p:nvSpPr>
        <p:spPr>
          <a:xfrm>
            <a:off x="918236" y="3902076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06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6F4B64D-6E92-E728-3BC5-CC0952569427}"/>
              </a:ext>
            </a:extLst>
          </p:cNvPr>
          <p:cNvSpPr txBox="1"/>
          <p:nvPr/>
        </p:nvSpPr>
        <p:spPr>
          <a:xfrm>
            <a:off x="3822092" y="3902076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253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43C8B43-3E25-DCBC-3B47-7F2EB121A223}"/>
              </a:ext>
            </a:extLst>
          </p:cNvPr>
          <p:cNvSpPr txBox="1"/>
          <p:nvPr/>
        </p:nvSpPr>
        <p:spPr>
          <a:xfrm>
            <a:off x="6689820" y="3895730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617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B89D863-72E2-F562-3E7E-9F7684DF4E0A}"/>
              </a:ext>
            </a:extLst>
          </p:cNvPr>
          <p:cNvSpPr txBox="1"/>
          <p:nvPr/>
        </p:nvSpPr>
        <p:spPr>
          <a:xfrm>
            <a:off x="918236" y="5931982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43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E5B9F19-BBE0-A24C-02E3-A1BC74FE6567}"/>
              </a:ext>
            </a:extLst>
          </p:cNvPr>
          <p:cNvSpPr txBox="1"/>
          <p:nvPr/>
        </p:nvSpPr>
        <p:spPr>
          <a:xfrm>
            <a:off x="3824614" y="5931981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23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754D5A0-1D77-BD78-14ED-0913D5E062D2}"/>
              </a:ext>
            </a:extLst>
          </p:cNvPr>
          <p:cNvSpPr txBox="1"/>
          <p:nvPr/>
        </p:nvSpPr>
        <p:spPr>
          <a:xfrm>
            <a:off x="6689820" y="5941511"/>
            <a:ext cx="7982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839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E0F23B2-6A90-38C8-1FD6-95A72C0C9F7C}"/>
              </a:ext>
            </a:extLst>
          </p:cNvPr>
          <p:cNvSpPr txBox="1"/>
          <p:nvPr/>
        </p:nvSpPr>
        <p:spPr>
          <a:xfrm>
            <a:off x="2575394" y="6096144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2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5BDA54E-F8B6-6C54-5F32-DED9500F3869}"/>
              </a:ext>
            </a:extLst>
          </p:cNvPr>
          <p:cNvSpPr txBox="1"/>
          <p:nvPr/>
        </p:nvSpPr>
        <p:spPr>
          <a:xfrm>
            <a:off x="1653632" y="5957280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DE0055A-E1BD-67A8-890B-A37C917D4D57}"/>
              </a:ext>
            </a:extLst>
          </p:cNvPr>
          <p:cNvSpPr txBox="1"/>
          <p:nvPr/>
        </p:nvSpPr>
        <p:spPr>
          <a:xfrm>
            <a:off x="2799060" y="5323597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4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3953007-D12B-8171-65BA-E8150406C869}"/>
              </a:ext>
            </a:extLst>
          </p:cNvPr>
          <p:cNvSpPr txBox="1"/>
          <p:nvPr/>
        </p:nvSpPr>
        <p:spPr>
          <a:xfrm>
            <a:off x="1846323" y="5054601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22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F6171D1D-366B-B711-90F9-F362863FEA0A}"/>
              </a:ext>
            </a:extLst>
          </p:cNvPr>
          <p:cNvCxnSpPr/>
          <p:nvPr/>
        </p:nvCxnSpPr>
        <p:spPr>
          <a:xfrm flipH="1" flipV="1">
            <a:off x="1677103" y="5811524"/>
            <a:ext cx="131284" cy="19726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B458CBCD-4AB7-0540-3505-858219557AF8}"/>
              </a:ext>
            </a:extLst>
          </p:cNvPr>
          <p:cNvCxnSpPr/>
          <p:nvPr/>
        </p:nvCxnSpPr>
        <p:spPr>
          <a:xfrm>
            <a:off x="3017864" y="5504549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1FC5A703-11D6-37D9-9AF3-E7D9A26F25D4}"/>
              </a:ext>
            </a:extLst>
          </p:cNvPr>
          <p:cNvCxnSpPr/>
          <p:nvPr/>
        </p:nvCxnSpPr>
        <p:spPr>
          <a:xfrm>
            <a:off x="2040630" y="5255982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994B9B4F-7DCE-CBE5-9080-E1785763B3E2}"/>
              </a:ext>
            </a:extLst>
          </p:cNvPr>
          <p:cNvSpPr txBox="1"/>
          <p:nvPr/>
        </p:nvSpPr>
        <p:spPr>
          <a:xfrm>
            <a:off x="4719999" y="6048194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0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9389A45-30FD-9A45-ACE1-BC47E53142A7}"/>
              </a:ext>
            </a:extLst>
          </p:cNvPr>
          <p:cNvSpPr txBox="1"/>
          <p:nvPr/>
        </p:nvSpPr>
        <p:spPr>
          <a:xfrm>
            <a:off x="5640683" y="6023518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BA7F2FD-2ED4-60A2-EDC6-E6FE838A50CB}"/>
              </a:ext>
            </a:extLst>
          </p:cNvPr>
          <p:cNvSpPr txBox="1"/>
          <p:nvPr/>
        </p:nvSpPr>
        <p:spPr>
          <a:xfrm>
            <a:off x="5440904" y="5334124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9817F14-2384-4E8F-6D07-BE9D58BFCFE5}"/>
              </a:ext>
            </a:extLst>
          </p:cNvPr>
          <p:cNvSpPr txBox="1"/>
          <p:nvPr/>
        </p:nvSpPr>
        <p:spPr>
          <a:xfrm>
            <a:off x="4651213" y="4855116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3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6DFADEC3-31FC-DDCC-2E73-1DA8677679D2}"/>
              </a:ext>
            </a:extLst>
          </p:cNvPr>
          <p:cNvCxnSpPr/>
          <p:nvPr/>
        </p:nvCxnSpPr>
        <p:spPr>
          <a:xfrm>
            <a:off x="5650655" y="5524128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117AF1FA-BF9F-0B28-9630-DB3FA74FB118}"/>
              </a:ext>
            </a:extLst>
          </p:cNvPr>
          <p:cNvCxnSpPr/>
          <p:nvPr/>
        </p:nvCxnSpPr>
        <p:spPr>
          <a:xfrm>
            <a:off x="4861819" y="5046857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4716FDB8-B331-5F77-5703-D6548BE95CDB}"/>
              </a:ext>
            </a:extLst>
          </p:cNvPr>
          <p:cNvCxnSpPr/>
          <p:nvPr/>
        </p:nvCxnSpPr>
        <p:spPr>
          <a:xfrm flipV="1">
            <a:off x="5875587" y="586009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8F3DEBAF-52A2-2649-1FB3-203733E7A99E}"/>
              </a:ext>
            </a:extLst>
          </p:cNvPr>
          <p:cNvCxnSpPr/>
          <p:nvPr/>
        </p:nvCxnSpPr>
        <p:spPr>
          <a:xfrm flipV="1">
            <a:off x="4938195" y="5888491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B5052A14-3EDC-639F-F870-E7A49AA86741}"/>
              </a:ext>
            </a:extLst>
          </p:cNvPr>
          <p:cNvSpPr txBox="1"/>
          <p:nvPr/>
        </p:nvSpPr>
        <p:spPr>
          <a:xfrm>
            <a:off x="8513581" y="5270999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9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CEBDE3DD-F4C3-432C-B0A9-B45FBD2451E6}"/>
              </a:ext>
            </a:extLst>
          </p:cNvPr>
          <p:cNvCxnSpPr/>
          <p:nvPr/>
        </p:nvCxnSpPr>
        <p:spPr>
          <a:xfrm>
            <a:off x="8733240" y="546274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B3CE581F-BD4C-0245-D7E3-A521810A3D41}"/>
              </a:ext>
            </a:extLst>
          </p:cNvPr>
          <p:cNvSpPr txBox="1"/>
          <p:nvPr/>
        </p:nvSpPr>
        <p:spPr>
          <a:xfrm>
            <a:off x="6663262" y="5709723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9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9FCEAB37-0103-CCD5-D83F-962073E23956}"/>
              </a:ext>
            </a:extLst>
          </p:cNvPr>
          <p:cNvCxnSpPr>
            <a:stCxn id="61" idx="0"/>
          </p:cNvCxnSpPr>
          <p:nvPr/>
        </p:nvCxnSpPr>
        <p:spPr>
          <a:xfrm flipV="1">
            <a:off x="6912593" y="5604517"/>
            <a:ext cx="118405" cy="10520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56FC5EBC-C566-3A04-7948-A2F791BA05D4}"/>
              </a:ext>
            </a:extLst>
          </p:cNvPr>
          <p:cNvSpPr txBox="1"/>
          <p:nvPr/>
        </p:nvSpPr>
        <p:spPr>
          <a:xfrm>
            <a:off x="7551724" y="5121281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4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BC4324F4-FC29-1D15-E749-529D358C9264}"/>
              </a:ext>
            </a:extLst>
          </p:cNvPr>
          <p:cNvCxnSpPr/>
          <p:nvPr/>
        </p:nvCxnSpPr>
        <p:spPr>
          <a:xfrm rot="5400000">
            <a:off x="7513662" y="5129037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17DD7171-4B20-141D-7568-B0BC96B3175E}"/>
              </a:ext>
            </a:extLst>
          </p:cNvPr>
          <p:cNvSpPr txBox="1"/>
          <p:nvPr/>
        </p:nvSpPr>
        <p:spPr>
          <a:xfrm>
            <a:off x="8294024" y="5949678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1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6ABD16B4-558B-5298-9412-6302B09AC152}"/>
              </a:ext>
            </a:extLst>
          </p:cNvPr>
          <p:cNvCxnSpPr/>
          <p:nvPr/>
        </p:nvCxnSpPr>
        <p:spPr>
          <a:xfrm rot="5400000">
            <a:off x="8274068" y="597554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577CD379-0361-8F90-1BA1-BB697752CDF4}"/>
              </a:ext>
            </a:extLst>
          </p:cNvPr>
          <p:cNvCxnSpPr/>
          <p:nvPr/>
        </p:nvCxnSpPr>
        <p:spPr>
          <a:xfrm flipV="1">
            <a:off x="2766336" y="595728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4C84C039-964B-E005-2D77-B32ABDEFFA58}"/>
              </a:ext>
            </a:extLst>
          </p:cNvPr>
          <p:cNvSpPr txBox="1"/>
          <p:nvPr/>
        </p:nvSpPr>
        <p:spPr>
          <a:xfrm>
            <a:off x="1693466" y="3960669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1C718D4-F90F-7669-1CD1-72BFDB899B7E}"/>
              </a:ext>
            </a:extLst>
          </p:cNvPr>
          <p:cNvSpPr txBox="1"/>
          <p:nvPr/>
        </p:nvSpPr>
        <p:spPr>
          <a:xfrm>
            <a:off x="2749735" y="4031886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3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155373A-475D-1ED1-5029-39D68E113E2B}"/>
              </a:ext>
            </a:extLst>
          </p:cNvPr>
          <p:cNvSpPr txBox="1"/>
          <p:nvPr/>
        </p:nvSpPr>
        <p:spPr>
          <a:xfrm>
            <a:off x="1725305" y="2939990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44AA432-9C45-C0F0-9B93-1BC737678D7D}"/>
              </a:ext>
            </a:extLst>
          </p:cNvPr>
          <p:cNvSpPr txBox="1"/>
          <p:nvPr/>
        </p:nvSpPr>
        <p:spPr>
          <a:xfrm>
            <a:off x="2587722" y="3354359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25</a:t>
            </a:r>
          </a:p>
        </p:txBody>
      </p: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6EE859AD-A190-A786-5BC1-80AF061F29F6}"/>
              </a:ext>
            </a:extLst>
          </p:cNvPr>
          <p:cNvCxnSpPr/>
          <p:nvPr/>
        </p:nvCxnSpPr>
        <p:spPr>
          <a:xfrm>
            <a:off x="1953162" y="3111888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83003344-67C6-6D2F-050F-C8ED57D677A8}"/>
              </a:ext>
            </a:extLst>
          </p:cNvPr>
          <p:cNvCxnSpPr/>
          <p:nvPr/>
        </p:nvCxnSpPr>
        <p:spPr>
          <a:xfrm>
            <a:off x="2771169" y="3527994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319987F6-BF75-25AD-0CA3-C27DBDF486D9}"/>
              </a:ext>
            </a:extLst>
          </p:cNvPr>
          <p:cNvCxnSpPr/>
          <p:nvPr/>
        </p:nvCxnSpPr>
        <p:spPr>
          <a:xfrm flipV="1">
            <a:off x="2957480" y="3868458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955706C7-F545-2D68-97B3-655DAC22B7D5}"/>
              </a:ext>
            </a:extLst>
          </p:cNvPr>
          <p:cNvCxnSpPr>
            <a:stCxn id="68" idx="0"/>
          </p:cNvCxnSpPr>
          <p:nvPr/>
        </p:nvCxnSpPr>
        <p:spPr>
          <a:xfrm flipH="1" flipV="1">
            <a:off x="1770333" y="3788615"/>
            <a:ext cx="172464" cy="1720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67A8A3F1-678F-91AF-ECDB-B2909FF8775D}"/>
              </a:ext>
            </a:extLst>
          </p:cNvPr>
          <p:cNvSpPr txBox="1"/>
          <p:nvPr/>
        </p:nvSpPr>
        <p:spPr>
          <a:xfrm>
            <a:off x="5284736" y="3522559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0C20FB3-D285-C0F9-D561-475498D14D5B}"/>
              </a:ext>
            </a:extLst>
          </p:cNvPr>
          <p:cNvSpPr txBox="1"/>
          <p:nvPr/>
        </p:nvSpPr>
        <p:spPr>
          <a:xfrm>
            <a:off x="5431851" y="4075908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4EDD841-39B1-442E-B320-5C84BD8BC8FA}"/>
              </a:ext>
            </a:extLst>
          </p:cNvPr>
          <p:cNvSpPr txBox="1"/>
          <p:nvPr/>
        </p:nvSpPr>
        <p:spPr>
          <a:xfrm>
            <a:off x="4701736" y="3089951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4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BC7957A-8F2C-719D-37C5-9E3652657A87}"/>
              </a:ext>
            </a:extLst>
          </p:cNvPr>
          <p:cNvSpPr txBox="1"/>
          <p:nvPr/>
        </p:nvSpPr>
        <p:spPr>
          <a:xfrm>
            <a:off x="4195832" y="2778295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1</a:t>
            </a: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539859C3-D2F5-9CB0-2545-C24A6756CB72}"/>
              </a:ext>
            </a:extLst>
          </p:cNvPr>
          <p:cNvCxnSpPr/>
          <p:nvPr/>
        </p:nvCxnSpPr>
        <p:spPr>
          <a:xfrm>
            <a:off x="4918650" y="3255171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874D4F36-37B1-E86A-ABB2-FE50E3FD582B}"/>
              </a:ext>
            </a:extLst>
          </p:cNvPr>
          <p:cNvCxnSpPr/>
          <p:nvPr/>
        </p:nvCxnSpPr>
        <p:spPr>
          <a:xfrm>
            <a:off x="4388332" y="295193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BB58004A-1D7B-2BC8-3FE6-E58376DA2D65}"/>
              </a:ext>
            </a:extLst>
          </p:cNvPr>
          <p:cNvCxnSpPr/>
          <p:nvPr/>
        </p:nvCxnSpPr>
        <p:spPr>
          <a:xfrm flipV="1">
            <a:off x="5666755" y="391248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5280C41F-F120-B784-F5BB-089EDCFE496A}"/>
              </a:ext>
            </a:extLst>
          </p:cNvPr>
          <p:cNvCxnSpPr/>
          <p:nvPr/>
        </p:nvCxnSpPr>
        <p:spPr>
          <a:xfrm rot="16200000" flipV="1">
            <a:off x="5284736" y="3545335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A55A9931-1173-59FB-BA13-AEA5E849E9AA}"/>
              </a:ext>
            </a:extLst>
          </p:cNvPr>
          <p:cNvSpPr txBox="1"/>
          <p:nvPr/>
        </p:nvSpPr>
        <p:spPr>
          <a:xfrm>
            <a:off x="8511766" y="3981923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6B8D2EF-9CC9-D0CC-1964-1281FF288A07}"/>
              </a:ext>
            </a:extLst>
          </p:cNvPr>
          <p:cNvSpPr txBox="1"/>
          <p:nvPr/>
        </p:nvSpPr>
        <p:spPr>
          <a:xfrm>
            <a:off x="7401751" y="4089645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8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693744F-A064-17DF-3728-F73D3BF5C5DB}"/>
              </a:ext>
            </a:extLst>
          </p:cNvPr>
          <p:cNvSpPr txBox="1"/>
          <p:nvPr/>
        </p:nvSpPr>
        <p:spPr>
          <a:xfrm>
            <a:off x="7819071" y="3236200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2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ED9E9AA-8BB1-69DA-CF6F-417A697D1493}"/>
              </a:ext>
            </a:extLst>
          </p:cNvPr>
          <p:cNvSpPr txBox="1"/>
          <p:nvPr/>
        </p:nvSpPr>
        <p:spPr>
          <a:xfrm>
            <a:off x="7255276" y="2887799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0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35A2D2DF-1299-7D77-C57B-3DBBD60D5919}"/>
              </a:ext>
            </a:extLst>
          </p:cNvPr>
          <p:cNvCxnSpPr/>
          <p:nvPr/>
        </p:nvCxnSpPr>
        <p:spPr>
          <a:xfrm>
            <a:off x="8037875" y="3435257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F1008309-3207-87E9-E4C4-E807B6B55694}"/>
              </a:ext>
            </a:extLst>
          </p:cNvPr>
          <p:cNvCxnSpPr/>
          <p:nvPr/>
        </p:nvCxnSpPr>
        <p:spPr>
          <a:xfrm>
            <a:off x="7474935" y="307954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BBCF8218-2FA7-8F3F-B4C5-466159476511}"/>
              </a:ext>
            </a:extLst>
          </p:cNvPr>
          <p:cNvCxnSpPr/>
          <p:nvPr/>
        </p:nvCxnSpPr>
        <p:spPr>
          <a:xfrm flipV="1">
            <a:off x="7636655" y="3963692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46BA2971-4777-F97E-50B3-AD88DB2B31B3}"/>
              </a:ext>
            </a:extLst>
          </p:cNvPr>
          <p:cNvCxnSpPr/>
          <p:nvPr/>
        </p:nvCxnSpPr>
        <p:spPr>
          <a:xfrm flipV="1">
            <a:off x="8729962" y="382222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00E7EA49-9237-824F-BB49-C3CDF7B75BE9}"/>
              </a:ext>
            </a:extLst>
          </p:cNvPr>
          <p:cNvSpPr txBox="1"/>
          <p:nvPr/>
        </p:nvSpPr>
        <p:spPr>
          <a:xfrm>
            <a:off x="2824725" y="1925055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16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F1454464-C306-9C15-7A90-DB711D47CE1C}"/>
              </a:ext>
            </a:extLst>
          </p:cNvPr>
          <p:cNvSpPr txBox="1"/>
          <p:nvPr/>
        </p:nvSpPr>
        <p:spPr>
          <a:xfrm>
            <a:off x="2234603" y="2057273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17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0A71135-668E-3402-788E-8F802986F375}"/>
              </a:ext>
            </a:extLst>
          </p:cNvPr>
          <p:cNvSpPr txBox="1"/>
          <p:nvPr/>
        </p:nvSpPr>
        <p:spPr>
          <a:xfrm>
            <a:off x="1718187" y="1941833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1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D67DCBE6-BD4E-89AD-78B7-0F6DEC019E71}"/>
              </a:ext>
            </a:extLst>
          </p:cNvPr>
          <p:cNvSpPr txBox="1"/>
          <p:nvPr/>
        </p:nvSpPr>
        <p:spPr>
          <a:xfrm>
            <a:off x="1665702" y="1032557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7</a:t>
            </a:r>
          </a:p>
        </p:txBody>
      </p: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196FAA92-F4CD-E29F-01E1-3ED96A4E3E09}"/>
              </a:ext>
            </a:extLst>
          </p:cNvPr>
          <p:cNvCxnSpPr/>
          <p:nvPr/>
        </p:nvCxnSpPr>
        <p:spPr>
          <a:xfrm flipV="1">
            <a:off x="1944486" y="1785350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E7D4E0E1-FAD5-1B77-DF19-86359EB71CF2}"/>
              </a:ext>
            </a:extLst>
          </p:cNvPr>
          <p:cNvCxnSpPr/>
          <p:nvPr/>
        </p:nvCxnSpPr>
        <p:spPr>
          <a:xfrm>
            <a:off x="1888182" y="1198697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1D20A4BF-27BB-66E0-B2B0-C5B54C47DFFA}"/>
              </a:ext>
            </a:extLst>
          </p:cNvPr>
          <p:cNvCxnSpPr/>
          <p:nvPr/>
        </p:nvCxnSpPr>
        <p:spPr>
          <a:xfrm flipV="1">
            <a:off x="2451401" y="1911951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812F086E-2358-B9B0-2FB2-BE1F38AF27FC}"/>
              </a:ext>
            </a:extLst>
          </p:cNvPr>
          <p:cNvCxnSpPr/>
          <p:nvPr/>
        </p:nvCxnSpPr>
        <p:spPr>
          <a:xfrm flipV="1">
            <a:off x="3047300" y="1756299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>
            <a:extLst>
              <a:ext uri="{FF2B5EF4-FFF2-40B4-BE49-F238E27FC236}">
                <a16:creationId xmlns:a16="http://schemas.microsoft.com/office/drawing/2014/main" id="{C8E3AF1E-1E5C-6400-DBFC-853AC2C71E73}"/>
              </a:ext>
            </a:extLst>
          </p:cNvPr>
          <p:cNvSpPr txBox="1"/>
          <p:nvPr/>
        </p:nvSpPr>
        <p:spPr>
          <a:xfrm>
            <a:off x="4609821" y="2013716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8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41F286D8-9EC0-C7E7-FC32-380622022E2B}"/>
              </a:ext>
            </a:extLst>
          </p:cNvPr>
          <p:cNvSpPr txBox="1"/>
          <p:nvPr/>
        </p:nvSpPr>
        <p:spPr>
          <a:xfrm>
            <a:off x="5211100" y="2043541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5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CA0DF06-F3F7-15EA-4015-96F5FA472FE0}"/>
              </a:ext>
            </a:extLst>
          </p:cNvPr>
          <p:cNvSpPr txBox="1"/>
          <p:nvPr/>
        </p:nvSpPr>
        <p:spPr>
          <a:xfrm>
            <a:off x="5659708" y="1242404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7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609F890-474F-27FC-B6F4-EC7BA9A80A5D}"/>
              </a:ext>
            </a:extLst>
          </p:cNvPr>
          <p:cNvSpPr txBox="1"/>
          <p:nvPr/>
        </p:nvSpPr>
        <p:spPr>
          <a:xfrm>
            <a:off x="4224453" y="845038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8</a:t>
            </a:r>
          </a:p>
        </p:txBody>
      </p: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F05ECA86-4385-F30D-7E38-C27946F23351}"/>
              </a:ext>
            </a:extLst>
          </p:cNvPr>
          <p:cNvCxnSpPr/>
          <p:nvPr/>
        </p:nvCxnSpPr>
        <p:spPr>
          <a:xfrm>
            <a:off x="5876954" y="1448956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157302A4-45DE-8178-DF34-44982BA05388}"/>
              </a:ext>
            </a:extLst>
          </p:cNvPr>
          <p:cNvCxnSpPr/>
          <p:nvPr/>
        </p:nvCxnSpPr>
        <p:spPr>
          <a:xfrm>
            <a:off x="4446933" y="1048948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:a16="http://schemas.microsoft.com/office/drawing/2014/main" id="{A335241B-9EF9-85FE-1A36-78B3A57EA2DA}"/>
              </a:ext>
            </a:extLst>
          </p:cNvPr>
          <p:cNvCxnSpPr/>
          <p:nvPr/>
        </p:nvCxnSpPr>
        <p:spPr>
          <a:xfrm flipV="1">
            <a:off x="5446004" y="1880113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41AB1EC7-D012-CDA6-E828-69CB75C11846}"/>
              </a:ext>
            </a:extLst>
          </p:cNvPr>
          <p:cNvCxnSpPr/>
          <p:nvPr/>
        </p:nvCxnSpPr>
        <p:spPr>
          <a:xfrm flipV="1">
            <a:off x="4841939" y="1711356"/>
            <a:ext cx="0" cy="3657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4F37F10E-694C-5FED-A31D-E6ABB817C3D7}"/>
              </a:ext>
            </a:extLst>
          </p:cNvPr>
          <p:cNvSpPr txBox="1"/>
          <p:nvPr/>
        </p:nvSpPr>
        <p:spPr>
          <a:xfrm>
            <a:off x="8244675" y="1965221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2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46CFA915-C465-5C13-2665-5C0B170F2354}"/>
              </a:ext>
            </a:extLst>
          </p:cNvPr>
          <p:cNvSpPr txBox="1"/>
          <p:nvPr/>
        </p:nvSpPr>
        <p:spPr>
          <a:xfrm>
            <a:off x="7286917" y="2043541"/>
            <a:ext cx="5296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3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B1904BFB-FD88-67CC-D159-39050F60BB4C}"/>
              </a:ext>
            </a:extLst>
          </p:cNvPr>
          <p:cNvSpPr txBox="1"/>
          <p:nvPr/>
        </p:nvSpPr>
        <p:spPr>
          <a:xfrm>
            <a:off x="8405935" y="1415555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58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3557472F-7CC4-C54B-C47A-976CE95C649F}"/>
              </a:ext>
            </a:extLst>
          </p:cNvPr>
          <p:cNvSpPr txBox="1"/>
          <p:nvPr/>
        </p:nvSpPr>
        <p:spPr>
          <a:xfrm>
            <a:off x="7474935" y="979744"/>
            <a:ext cx="4986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40</a:t>
            </a:r>
          </a:p>
        </p:txBody>
      </p:sp>
      <p:cxnSp>
        <p:nvCxnSpPr>
          <p:cNvPr id="112" name="Straight Arrow Connector 111">
            <a:extLst>
              <a:ext uri="{FF2B5EF4-FFF2-40B4-BE49-F238E27FC236}">
                <a16:creationId xmlns:a16="http://schemas.microsoft.com/office/drawing/2014/main" id="{24CDE5FB-8B18-E24B-B496-0B772956D629}"/>
              </a:ext>
            </a:extLst>
          </p:cNvPr>
          <p:cNvCxnSpPr/>
          <p:nvPr/>
        </p:nvCxnSpPr>
        <p:spPr>
          <a:xfrm>
            <a:off x="8632234" y="1613054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34405103-125A-7AD8-B267-F97F22C2B35D}"/>
              </a:ext>
            </a:extLst>
          </p:cNvPr>
          <p:cNvCxnSpPr/>
          <p:nvPr/>
        </p:nvCxnSpPr>
        <p:spPr>
          <a:xfrm>
            <a:off x="7697415" y="1165548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75F394B9-4149-58B3-4258-0C424BF5CCE2}"/>
              </a:ext>
            </a:extLst>
          </p:cNvPr>
          <p:cNvCxnSpPr/>
          <p:nvPr/>
        </p:nvCxnSpPr>
        <p:spPr>
          <a:xfrm flipV="1">
            <a:off x="7521821" y="1895103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84253E65-FC15-9CC2-CD29-2D6077413B33}"/>
              </a:ext>
            </a:extLst>
          </p:cNvPr>
          <p:cNvCxnSpPr/>
          <p:nvPr/>
        </p:nvCxnSpPr>
        <p:spPr>
          <a:xfrm rot="16200000" flipV="1">
            <a:off x="8244675" y="1975412"/>
            <a:ext cx="0" cy="1999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33F1B626-7C0D-5A70-0E09-4221C89FC515}"/>
              </a:ext>
            </a:extLst>
          </p:cNvPr>
          <p:cNvSpPr txBox="1"/>
          <p:nvPr/>
        </p:nvSpPr>
        <p:spPr>
          <a:xfrm>
            <a:off x="9347370" y="1785350"/>
            <a:ext cx="2594917" cy="34220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/>
              <a:t>SUPPLEMENTARY FIGURE 4</a:t>
            </a:r>
            <a:r>
              <a:rPr lang="en-US" sz="1400" b="1" dirty="0" smtClean="0"/>
              <a:t>. 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aplan-Meier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alysis for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CGA bladder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ncer data;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verall Survival (OS)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21/RAD50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RNA expression in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hole 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21/BARD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hole 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. </a:t>
            </a:r>
            <a:r>
              <a:rPr lang="en-US" sz="14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D50/BARD1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RNA expression in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hole 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, (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i="1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BB2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High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hort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5832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561</Words>
  <Application>Microsoft Office PowerPoint</Application>
  <PresentationFormat>Widescreen</PresentationFormat>
  <Paragraphs>16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da Albarakati</dc:creator>
  <cp:lastModifiedBy>NADA ALBARAKATI</cp:lastModifiedBy>
  <cp:revision>16</cp:revision>
  <dcterms:created xsi:type="dcterms:W3CDTF">2023-03-14T06:38:40Z</dcterms:created>
  <dcterms:modified xsi:type="dcterms:W3CDTF">2023-06-06T06:17:06Z</dcterms:modified>
</cp:coreProperties>
</file>